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AC312-7022-4A3F-9CF1-6937D69456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570C3-34F4-4A96-8436-D2C4A4D9A6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F4A26-5877-4F33-A66E-9F7D87F578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4CC59-0C3B-42D3-882E-C7AD839431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032A70-AADF-4265-AFA2-30D431AEF6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037325-348B-4624-829F-1E2637552F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A8ABC-8674-43EE-B7A0-C4E61D5319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08FD42-75F5-4B95-982F-67D0C964E5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167A1-02CF-4B7B-8F3B-5FB5786F7D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D4954-DAC2-4BC9-A0D0-AF998DB647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AB14F5-CB28-4045-BCF2-D523659901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B56B3-441F-4319-97E3-09261C56B2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42AA4F-C415-4BB6-8B88-46DA7388541E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314360" y="2916360"/>
          <a:ext cx="4057920" cy="2997000"/>
        </p:xfrm>
        <a:graphic>
          <a:graphicData uri="http://schemas.openxmlformats.org/drawingml/2006/table">
            <a:tbl>
              <a:tblPr/>
              <a:tblGrid>
                <a:gridCol w="1801800"/>
                <a:gridCol w="1503360"/>
                <a:gridCol w="752760"/>
              </a:tblGrid>
              <a:tr h="377640">
                <a:tc gridSpan="3"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clear FOXK2  vs Clinicopathological paramete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24080"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arson's correlation coeffici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i-FI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r>
                        <a:rPr b="0" lang="fi-FI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06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 statu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5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04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88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92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 statu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88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mour grad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1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92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88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i-FI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ymph node metastasis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92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06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a-DK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mour sta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0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888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16"/>
          <p:cNvSpPr/>
          <p:nvPr/>
        </p:nvSpPr>
        <p:spPr>
          <a:xfrm>
            <a:off x="4854600" y="8793000"/>
            <a:ext cx="200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2:38:11Z</dcterms:modified>
  <cp:revision>201</cp:revision>
  <dc:subject/>
  <dc:title>PowerPoint Presentation</dc:title>
</cp:coreProperties>
</file>